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-109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92EEE4BD-9A06-46AB-A7D1-5706FE4DB436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B8F3E5FF-C2F8-4588-8145-E067E99C96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205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F3E5FF-C2F8-4588-8145-E067E99C967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6471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A7C47-A086-48F3-BA35-7A538ABA908B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552C-6AB6-4628-8552-F6D1EEA1D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839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A7C47-A086-48F3-BA35-7A538ABA908B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552C-6AB6-4628-8552-F6D1EEA1D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477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A7C47-A086-48F3-BA35-7A538ABA908B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552C-6AB6-4628-8552-F6D1EEA1D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453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A7C47-A086-48F3-BA35-7A538ABA908B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552C-6AB6-4628-8552-F6D1EEA1D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1719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A7C47-A086-48F3-BA35-7A538ABA908B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552C-6AB6-4628-8552-F6D1EEA1D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138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A7C47-A086-48F3-BA35-7A538ABA908B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552C-6AB6-4628-8552-F6D1EEA1D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907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A7C47-A086-48F3-BA35-7A538ABA908B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552C-6AB6-4628-8552-F6D1EEA1D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4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A7C47-A086-48F3-BA35-7A538ABA908B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552C-6AB6-4628-8552-F6D1EEA1D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56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A7C47-A086-48F3-BA35-7A538ABA908B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552C-6AB6-4628-8552-F6D1EEA1D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230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A7C47-A086-48F3-BA35-7A538ABA908B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552C-6AB6-4628-8552-F6D1EEA1D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8687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A7C47-A086-48F3-BA35-7A538ABA908B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D4552C-6AB6-4628-8552-F6D1EEA1D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780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3A7C47-A086-48F3-BA35-7A538ABA908B}" type="datetimeFigureOut">
              <a:rPr lang="en-US" smtClean="0"/>
              <a:t>11/1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D4552C-6AB6-4628-8552-F6D1EEA1D8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887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://www.genome.jp/kegg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504543" y="4441144"/>
            <a:ext cx="1868607" cy="1121342"/>
            <a:chOff x="1363867" y="4495139"/>
            <a:chExt cx="1868607" cy="1121342"/>
          </a:xfrm>
        </p:grpSpPr>
        <p:sp>
          <p:nvSpPr>
            <p:cNvPr id="9" name="Rectangle 8"/>
            <p:cNvSpPr/>
            <p:nvPr/>
          </p:nvSpPr>
          <p:spPr>
            <a:xfrm>
              <a:off x="1363867" y="4495139"/>
              <a:ext cx="1868607" cy="11213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641974" y="4537343"/>
              <a:ext cx="15905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otein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ownregulated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in biofilm</a:t>
              </a:r>
            </a:p>
          </p:txBody>
        </p:sp>
        <p:sp>
          <p:nvSpPr>
            <p:cNvPr id="6" name="Rectangle 5"/>
            <p:cNvSpPr/>
            <p:nvPr/>
          </p:nvSpPr>
          <p:spPr>
            <a:xfrm>
              <a:off x="1478754" y="4595048"/>
              <a:ext cx="228600" cy="152400"/>
            </a:xfrm>
            <a:prstGeom prst="rect">
              <a:avLst/>
            </a:prstGeom>
            <a:solidFill>
              <a:srgbClr val="92D05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>
              <a:off x="1478754" y="5236047"/>
              <a:ext cx="228600" cy="1524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641974" y="5209344"/>
              <a:ext cx="134684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= gene annotated in </a:t>
              </a:r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H</a:t>
              </a:r>
              <a:r>
                <a:rPr 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fluenzae</a:t>
              </a:r>
              <a:endParaRPr 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641974" y="4842821"/>
              <a:ext cx="14269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otein upregulated 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in biofilm</a:t>
              </a: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1478754" y="4900526"/>
              <a:ext cx="228600" cy="152400"/>
            </a:xfrm>
            <a:prstGeom prst="rect">
              <a:avLst/>
            </a:prstGeom>
            <a:solidFill>
              <a:srgbClr val="FF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16" name="Tab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8511430"/>
              </p:ext>
            </p:extLst>
          </p:nvPr>
        </p:nvGraphicFramePr>
        <p:xfrm>
          <a:off x="5053097" y="436099"/>
          <a:ext cx="3851753" cy="3708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0412"/>
                <a:gridCol w="742036"/>
                <a:gridCol w="450166"/>
                <a:gridCol w="717452"/>
                <a:gridCol w="1181687"/>
              </a:tblGrid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</a:t>
                      </a:r>
                      <a:endParaRPr lang="en-US" sz="1000" u="none" strike="noStrike" dirty="0" smtClean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 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locu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 numb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film:Planktonic</a:t>
                      </a: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atio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X87237.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HI02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lB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.1.5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regulate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X87856.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HI097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kA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.1.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regulate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X87882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HI100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dA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.5.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regulate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X88202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HI137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kA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.2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regulate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X88208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HI138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h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.1.3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regulate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X88293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HI14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ykA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.1.4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regulate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X88535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HI17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mC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.1.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regulate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X88675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HI19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o2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.1.4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regulat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X88704.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HI19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d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.1.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regulate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405" y="436099"/>
            <a:ext cx="4225037" cy="3740347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271871" y="4617253"/>
            <a:ext cx="4657044" cy="13849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2:  (A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The genes encoding proteins involved in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ergy metabolism that were found to be differentially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pressed in the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ofilm:planktoni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amples were plotted on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KEGG pathways using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website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hlinkClick r:id="rId4"/>
              </a:rPr>
              <a:t>http://www.genome.jp/kegg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  <a:hlinkClick r:id="rId4"/>
              </a:rPr>
              <a:t>/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nformation for the proteins plotted in the pyruvate metabolism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thway that had differential expression in our study.</a:t>
            </a:r>
          </a:p>
          <a:p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56405" y="66767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124534" y="66767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1723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5</TotalTime>
  <Words>142</Words>
  <Application>Microsoft Office PowerPoint</Application>
  <PresentationFormat>On-screen Show (4:3)</PresentationFormat>
  <Paragraphs>6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borah Post</dc:creator>
  <cp:lastModifiedBy>Deborah Post</cp:lastModifiedBy>
  <cp:revision>18</cp:revision>
  <cp:lastPrinted>2014-11-11T23:24:19Z</cp:lastPrinted>
  <dcterms:created xsi:type="dcterms:W3CDTF">2014-11-06T19:06:26Z</dcterms:created>
  <dcterms:modified xsi:type="dcterms:W3CDTF">2014-11-18T00:48:24Z</dcterms:modified>
</cp:coreProperties>
</file>